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145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5656340289197524E-2"/>
          <c:y val="5.3912219305920092E-2"/>
          <c:w val="0.93418633507981019"/>
          <c:h val="0.63393372703412076"/>
        </c:manualLayout>
      </c:layout>
      <c:barChart>
        <c:barDir val="col"/>
        <c:grouping val="clustered"/>
        <c:varyColors val="0"/>
        <c:ser>
          <c:idx val="0"/>
          <c:order val="0"/>
          <c:tx>
            <c:v>fine pro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D$2:$D$78</c:f>
              <c:numCache>
                <c:formatCode>0.000_);[Red]\(0.000\)</c:formatCode>
                <c:ptCount val="77"/>
                <c:pt idx="0">
                  <c:v>0.98106719280144439</c:v>
                </c:pt>
                <c:pt idx="1">
                  <c:v>1.0222803884997718</c:v>
                </c:pt>
                <c:pt idx="2">
                  <c:v>1.5394593642731007</c:v>
                </c:pt>
                <c:pt idx="3">
                  <c:v>1.1991049068433899</c:v>
                </c:pt>
                <c:pt idx="4">
                  <c:v>1.8054170916089602</c:v>
                </c:pt>
                <c:pt idx="5">
                  <c:v>3.0124789033512571</c:v>
                </c:pt>
                <c:pt idx="6">
                  <c:v>1.3918300065477491</c:v>
                </c:pt>
                <c:pt idx="7">
                  <c:v>2.5285496041588131</c:v>
                </c:pt>
                <c:pt idx="8">
                  <c:v>2.8078945098117027</c:v>
                </c:pt>
                <c:pt idx="9">
                  <c:v>2.0124487460068656</c:v>
                </c:pt>
                <c:pt idx="10">
                  <c:v>0.84196356276910256</c:v>
                </c:pt>
                <c:pt idx="11">
                  <c:v>1.4260916585646544</c:v>
                </c:pt>
                <c:pt idx="12">
                  <c:v>0.98999638782515531</c:v>
                </c:pt>
                <c:pt idx="13">
                  <c:v>1.1126901416694777</c:v>
                </c:pt>
                <c:pt idx="14">
                  <c:v>1.3097676316233298</c:v>
                </c:pt>
                <c:pt idx="15">
                  <c:v>1.3859499662691721</c:v>
                </c:pt>
                <c:pt idx="16">
                  <c:v>1.7042526190995853</c:v>
                </c:pt>
                <c:pt idx="17">
                  <c:v>1.3196358112264133</c:v>
                </c:pt>
                <c:pt idx="18">
                  <c:v>1.8620811018075758</c:v>
                </c:pt>
                <c:pt idx="19">
                  <c:v>0.76260616877318999</c:v>
                </c:pt>
                <c:pt idx="20">
                  <c:v>1.1600677890434332</c:v>
                </c:pt>
                <c:pt idx="21" formatCode="0.000">
                  <c:v>1.344425902299649</c:v>
                </c:pt>
                <c:pt idx="22" formatCode="0.000">
                  <c:v>1.8752301682573067</c:v>
                </c:pt>
                <c:pt idx="23" formatCode="0.000">
                  <c:v>1.8851250391872856</c:v>
                </c:pt>
                <c:pt idx="24" formatCode="0.000">
                  <c:v>2.132582797277724</c:v>
                </c:pt>
                <c:pt idx="25" formatCode="0.000">
                  <c:v>0.91180309629159317</c:v>
                </c:pt>
                <c:pt idx="26" formatCode="0.000">
                  <c:v>0.96753450167662047</c:v>
                </c:pt>
                <c:pt idx="27" formatCode="0.000">
                  <c:v>2.1584973055020935</c:v>
                </c:pt>
                <c:pt idx="28" formatCode="0.000">
                  <c:v>3.1421506577511464</c:v>
                </c:pt>
                <c:pt idx="29" formatCode="0.000">
                  <c:v>2.1064566340601996</c:v>
                </c:pt>
                <c:pt idx="30" formatCode="0.000">
                  <c:v>2.0959730976805098</c:v>
                </c:pt>
                <c:pt idx="31" formatCode="0.000">
                  <c:v>2.9233853796702318</c:v>
                </c:pt>
                <c:pt idx="32" formatCode="0.000">
                  <c:v>0.71641246651719281</c:v>
                </c:pt>
                <c:pt idx="33" formatCode="0.000">
                  <c:v>1.2263422587749757</c:v>
                </c:pt>
                <c:pt idx="34" formatCode="0.000">
                  <c:v>1.038663807813647</c:v>
                </c:pt>
                <c:pt idx="35" formatCode="0.000">
                  <c:v>0.70460608643028633</c:v>
                </c:pt>
                <c:pt idx="36" formatCode="0.000">
                  <c:v>1.2063607045774718</c:v>
                </c:pt>
                <c:pt idx="37" formatCode="0.000">
                  <c:v>0.60979719923615539</c:v>
                </c:pt>
                <c:pt idx="38" formatCode="0.000">
                  <c:v>0.44617533978848778</c:v>
                </c:pt>
                <c:pt idx="39" formatCode="0.000">
                  <c:v>0.64069950693466149</c:v>
                </c:pt>
                <c:pt idx="40" formatCode="0.000">
                  <c:v>1.3588316702712355</c:v>
                </c:pt>
                <c:pt idx="41" formatCode="0.000">
                  <c:v>0.65978152741125817</c:v>
                </c:pt>
                <c:pt idx="42" formatCode="0.000">
                  <c:v>0.39119795531657381</c:v>
                </c:pt>
                <c:pt idx="43" formatCode="0.000">
                  <c:v>0.46306805392964145</c:v>
                </c:pt>
                <c:pt idx="44" formatCode="0.000">
                  <c:v>0.29424674001468282</c:v>
                </c:pt>
                <c:pt idx="45" formatCode="0.000">
                  <c:v>0.79811129387487845</c:v>
                </c:pt>
                <c:pt idx="46" formatCode="0.000">
                  <c:v>0.53118789063275074</c:v>
                </c:pt>
                <c:pt idx="47" formatCode="0.000">
                  <c:v>0.7831367031091887</c:v>
                </c:pt>
                <c:pt idx="48" formatCode="0.000">
                  <c:v>1.4899519385305262</c:v>
                </c:pt>
                <c:pt idx="49" formatCode="0.000">
                  <c:v>1.5402266136232865</c:v>
                </c:pt>
                <c:pt idx="50" formatCode="0.000">
                  <c:v>1.5715647810472431</c:v>
                </c:pt>
                <c:pt idx="51" formatCode="0.000">
                  <c:v>0.93352418996408659</c:v>
                </c:pt>
                <c:pt idx="52" formatCode="0.000">
                  <c:v>0.62566538820214679</c:v>
                </c:pt>
                <c:pt idx="53" formatCode="0.000">
                  <c:v>0.97717803230222833</c:v>
                </c:pt>
                <c:pt idx="54" formatCode="0.000">
                  <c:v>0.95761317387249745</c:v>
                </c:pt>
                <c:pt idx="55" formatCode="0.000">
                  <c:v>0.7038186261768471</c:v>
                </c:pt>
                <c:pt idx="56" formatCode="0.000">
                  <c:v>0.74312729518442822</c:v>
                </c:pt>
                <c:pt idx="57" formatCode="0.000">
                  <c:v>0.71183542729022409</c:v>
                </c:pt>
                <c:pt idx="58" formatCode="0.000">
                  <c:v>1.033498103136967</c:v>
                </c:pt>
                <c:pt idx="59" formatCode="0.000">
                  <c:v>0.86067987678449198</c:v>
                </c:pt>
                <c:pt idx="60" formatCode="0.000">
                  <c:v>1.0798902319490467</c:v>
                </c:pt>
                <c:pt idx="61" formatCode="0.000">
                  <c:v>2.5448999523800078</c:v>
                </c:pt>
                <c:pt idx="62" formatCode="0.000">
                  <c:v>0.16905488887509315</c:v>
                </c:pt>
                <c:pt idx="63" formatCode="0.000">
                  <c:v>1.7717507192603028</c:v>
                </c:pt>
                <c:pt idx="64" formatCode="0.000">
                  <c:v>1.4951374858628148</c:v>
                </c:pt>
                <c:pt idx="65" formatCode="0.000">
                  <c:v>2.1402552907795793</c:v>
                </c:pt>
                <c:pt idx="66" formatCode="0.000">
                  <c:v>1.6704671908172779</c:v>
                </c:pt>
                <c:pt idx="67" formatCode="0.000">
                  <c:v>0.96097319688882699</c:v>
                </c:pt>
                <c:pt idx="68" formatCode="0.000">
                  <c:v>1.2572174309014068</c:v>
                </c:pt>
                <c:pt idx="69" formatCode="0.000">
                  <c:v>1.8957607025933059</c:v>
                </c:pt>
                <c:pt idx="70" formatCode="0.000">
                  <c:v>1.0413822516319768</c:v>
                </c:pt>
                <c:pt idx="71" formatCode="0.000">
                  <c:v>1.9818579852774858</c:v>
                </c:pt>
                <c:pt idx="72" formatCode="0.000">
                  <c:v>1.607513058790849</c:v>
                </c:pt>
                <c:pt idx="73" formatCode="0.000">
                  <c:v>1.5370385602888945</c:v>
                </c:pt>
                <c:pt idx="74" formatCode="0.000">
                  <c:v>1.3870606226252244</c:v>
                </c:pt>
                <c:pt idx="75" formatCode="0.000">
                  <c:v>5.0926109476378505</c:v>
                </c:pt>
                <c:pt idx="76" formatCode="0.000">
                  <c:v>4.08367805214389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D0-4E92-BFB8-E33126B8F1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729248"/>
        <c:axId val="197728464"/>
      </c:barChart>
      <c:catAx>
        <c:axId val="1977292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728464"/>
        <c:crosses val="autoZero"/>
        <c:auto val="1"/>
        <c:lblAlgn val="ctr"/>
        <c:lblOffset val="100"/>
        <c:noMultiLvlLbl val="0"/>
      </c:catAx>
      <c:valAx>
        <c:axId val="197728464"/>
        <c:scaling>
          <c:orientation val="minMax"/>
        </c:scaling>
        <c:delete val="0"/>
        <c:axPos val="l"/>
        <c:numFmt formatCode="@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729248"/>
        <c:crosses val="autoZero"/>
        <c:crossBetween val="between"/>
        <c:majorUnit val="1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8356878846404917E-2"/>
          <c:y val="0.17469925634295713"/>
          <c:w val="0.92639235918837759"/>
          <c:h val="0.57122955784373108"/>
        </c:manualLayout>
      </c:layout>
      <c:barChart>
        <c:barDir val="col"/>
        <c:grouping val="clustered"/>
        <c:varyColors val="0"/>
        <c:ser>
          <c:idx val="0"/>
          <c:order val="0"/>
          <c:tx>
            <c:v>pro coarse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All weekly conc.'!$A$2:$A$78</c:f>
              <c:strCache>
                <c:ptCount val="77"/>
                <c:pt idx="0">
                  <c:v>1st week, Sep.,2014</c:v>
                </c:pt>
                <c:pt idx="1">
                  <c:v>2nd week</c:v>
                </c:pt>
                <c:pt idx="2">
                  <c:v>3rd week</c:v>
                </c:pt>
                <c:pt idx="3">
                  <c:v>4th week</c:v>
                </c:pt>
                <c:pt idx="4">
                  <c:v>1st week, Oct.</c:v>
                </c:pt>
                <c:pt idx="5">
                  <c:v>2nd week</c:v>
                </c:pt>
                <c:pt idx="6">
                  <c:v>1st week, Nov.</c:v>
                </c:pt>
                <c:pt idx="7">
                  <c:v>2nd week</c:v>
                </c:pt>
                <c:pt idx="8">
                  <c:v>3rd week</c:v>
                </c:pt>
                <c:pt idx="9">
                  <c:v>4th week</c:v>
                </c:pt>
                <c:pt idx="10">
                  <c:v>1st week, Dec.</c:v>
                </c:pt>
                <c:pt idx="11">
                  <c:v>2nd week</c:v>
                </c:pt>
                <c:pt idx="12">
                  <c:v>3rd week</c:v>
                </c:pt>
                <c:pt idx="13">
                  <c:v>4th week</c:v>
                </c:pt>
                <c:pt idx="14">
                  <c:v>1st week, Jan., 2015</c:v>
                </c:pt>
                <c:pt idx="15">
                  <c:v>2nd week</c:v>
                </c:pt>
                <c:pt idx="16">
                  <c:v>3rd week</c:v>
                </c:pt>
                <c:pt idx="17">
                  <c:v>1st week, Feb.</c:v>
                </c:pt>
                <c:pt idx="18">
                  <c:v>2nd week</c:v>
                </c:pt>
                <c:pt idx="19">
                  <c:v>3rd week</c:v>
                </c:pt>
                <c:pt idx="20">
                  <c:v>4th week</c:v>
                </c:pt>
                <c:pt idx="21">
                  <c:v>1st week, Mar.</c:v>
                </c:pt>
                <c:pt idx="22">
                  <c:v>2nd week</c:v>
                </c:pt>
                <c:pt idx="23">
                  <c:v>3rd week</c:v>
                </c:pt>
                <c:pt idx="24">
                  <c:v>4th week</c:v>
                </c:pt>
                <c:pt idx="25">
                  <c:v>1st week, Apr.</c:v>
                </c:pt>
                <c:pt idx="26">
                  <c:v>2nd week</c:v>
                </c:pt>
                <c:pt idx="27">
                  <c:v>3rd week</c:v>
                </c:pt>
                <c:pt idx="28">
                  <c:v>4th week</c:v>
                </c:pt>
                <c:pt idx="29">
                  <c:v>1st week, May</c:v>
                </c:pt>
                <c:pt idx="30">
                  <c:v>2nd week</c:v>
                </c:pt>
                <c:pt idx="31">
                  <c:v>3rd week</c:v>
                </c:pt>
                <c:pt idx="32">
                  <c:v>1st week, Jun.</c:v>
                </c:pt>
                <c:pt idx="33">
                  <c:v>2nd week</c:v>
                </c:pt>
                <c:pt idx="34">
                  <c:v>3rd week</c:v>
                </c:pt>
                <c:pt idx="35">
                  <c:v>4th week</c:v>
                </c:pt>
                <c:pt idx="36">
                  <c:v>1st week, Jul.</c:v>
                </c:pt>
                <c:pt idx="37">
                  <c:v>2nd week</c:v>
                </c:pt>
                <c:pt idx="38">
                  <c:v>3rd week</c:v>
                </c:pt>
                <c:pt idx="39">
                  <c:v>4th week</c:v>
                </c:pt>
                <c:pt idx="40">
                  <c:v>1st week, Aug.</c:v>
                </c:pt>
                <c:pt idx="41">
                  <c:v>2nd week</c:v>
                </c:pt>
                <c:pt idx="42">
                  <c:v>3rd week</c:v>
                </c:pt>
                <c:pt idx="43">
                  <c:v>4th week</c:v>
                </c:pt>
                <c:pt idx="44">
                  <c:v>1st week, Sep.</c:v>
                </c:pt>
                <c:pt idx="45">
                  <c:v>2nd week</c:v>
                </c:pt>
                <c:pt idx="46">
                  <c:v>3rd week</c:v>
                </c:pt>
                <c:pt idx="47">
                  <c:v>1st week, Oct.</c:v>
                </c:pt>
                <c:pt idx="48">
                  <c:v>2nd week</c:v>
                </c:pt>
                <c:pt idx="49">
                  <c:v>3rd week</c:v>
                </c:pt>
                <c:pt idx="50">
                  <c:v>4th week</c:v>
                </c:pt>
                <c:pt idx="51">
                  <c:v>1st week, Nov.</c:v>
                </c:pt>
                <c:pt idx="52">
                  <c:v>2nd week</c:v>
                </c:pt>
                <c:pt idx="53">
                  <c:v>3rd week</c:v>
                </c:pt>
                <c:pt idx="54">
                  <c:v>4th week</c:v>
                </c:pt>
                <c:pt idx="55">
                  <c:v>1st week, Dec.</c:v>
                </c:pt>
                <c:pt idx="56">
                  <c:v>2nd week</c:v>
                </c:pt>
                <c:pt idx="57">
                  <c:v>3rd week</c:v>
                </c:pt>
                <c:pt idx="58">
                  <c:v>1st week, Jan., 2016</c:v>
                </c:pt>
                <c:pt idx="59">
                  <c:v>2nd week</c:v>
                </c:pt>
                <c:pt idx="60">
                  <c:v>3rd week</c:v>
                </c:pt>
                <c:pt idx="61">
                  <c:v>4th week</c:v>
                </c:pt>
                <c:pt idx="62">
                  <c:v>1st week, Feb.</c:v>
                </c:pt>
                <c:pt idx="63">
                  <c:v>2nd week</c:v>
                </c:pt>
                <c:pt idx="64">
                  <c:v>3rd week</c:v>
                </c:pt>
                <c:pt idx="65">
                  <c:v>4th week</c:v>
                </c:pt>
                <c:pt idx="66">
                  <c:v>1st week, Mar.</c:v>
                </c:pt>
                <c:pt idx="67">
                  <c:v>2nd week</c:v>
                </c:pt>
                <c:pt idx="68">
                  <c:v>3rd week</c:v>
                </c:pt>
                <c:pt idx="69">
                  <c:v>4th week</c:v>
                </c:pt>
                <c:pt idx="70">
                  <c:v>1st week, Apr.</c:v>
                </c:pt>
                <c:pt idx="71">
                  <c:v>2nd week</c:v>
                </c:pt>
                <c:pt idx="72">
                  <c:v>3rd week</c:v>
                </c:pt>
                <c:pt idx="73">
                  <c:v>4th week</c:v>
                </c:pt>
                <c:pt idx="74">
                  <c:v>1st week, May</c:v>
                </c:pt>
                <c:pt idx="75">
                  <c:v>2nd week</c:v>
                </c:pt>
                <c:pt idx="76">
                  <c:v>3rd week</c:v>
                </c:pt>
              </c:strCache>
            </c:strRef>
          </c:cat>
          <c:val>
            <c:numRef>
              <c:f>'All weekly conc.'!$P$2:$P$78</c:f>
              <c:numCache>
                <c:formatCode>General</c:formatCode>
                <c:ptCount val="77"/>
                <c:pt idx="0">
                  <c:v>0.45723762029008508</c:v>
                </c:pt>
                <c:pt idx="1">
                  <c:v>0.22590532699061489</c:v>
                </c:pt>
                <c:pt idx="2">
                  <c:v>0.17006478699974206</c:v>
                </c:pt>
                <c:pt idx="3">
                  <c:v>0.17804153455425703</c:v>
                </c:pt>
                <c:pt idx="4">
                  <c:v>0.10910484186194169</c:v>
                </c:pt>
                <c:pt idx="5">
                  <c:v>9.764570824817953E-2</c:v>
                </c:pt>
                <c:pt idx="6">
                  <c:v>0.13331949592253814</c:v>
                </c:pt>
                <c:pt idx="7">
                  <c:v>0.14924984126669183</c:v>
                </c:pt>
                <c:pt idx="8">
                  <c:v>8.1454101271850626E-2</c:v>
                </c:pt>
                <c:pt idx="9">
                  <c:v>0.1194197156689617</c:v>
                </c:pt>
                <c:pt idx="10">
                  <c:v>4.2453361673842741E-2</c:v>
                </c:pt>
                <c:pt idx="11">
                  <c:v>8.1794733526458871E-2</c:v>
                </c:pt>
                <c:pt idx="12">
                  <c:v>4.2453361673842741E-2</c:v>
                </c:pt>
                <c:pt idx="13">
                  <c:v>5.4454861207563654E-2</c:v>
                </c:pt>
                <c:pt idx="14">
                  <c:v>0.10318409260012501</c:v>
                </c:pt>
                <c:pt idx="15">
                  <c:v>5.7361810254171711E-2</c:v>
                </c:pt>
                <c:pt idx="16">
                  <c:v>5.7031099327367614E-2</c:v>
                </c:pt>
                <c:pt idx="17">
                  <c:v>4.641858568622393E-2</c:v>
                </c:pt>
                <c:pt idx="18">
                  <c:v>0.10046336534455048</c:v>
                </c:pt>
                <c:pt idx="19">
                  <c:v>4.277084416357467E-2</c:v>
                </c:pt>
                <c:pt idx="20">
                  <c:v>0.17835240282545289</c:v>
                </c:pt>
                <c:pt idx="21">
                  <c:v>9.6689953669715681E-2</c:v>
                </c:pt>
                <c:pt idx="22">
                  <c:v>0.11741560745252881</c:v>
                </c:pt>
                <c:pt idx="23">
                  <c:v>0.19969317893212168</c:v>
                </c:pt>
                <c:pt idx="24">
                  <c:v>0.12947663495307449</c:v>
                </c:pt>
                <c:pt idx="25">
                  <c:v>0.11830521984563186</c:v>
                </c:pt>
                <c:pt idx="26">
                  <c:v>8.8316353003035766E-2</c:v>
                </c:pt>
                <c:pt idx="27">
                  <c:v>0.23158363360384138</c:v>
                </c:pt>
                <c:pt idx="28">
                  <c:v>0.14495721343677453</c:v>
                </c:pt>
                <c:pt idx="29">
                  <c:v>0.19904167840631762</c:v>
                </c:pt>
                <c:pt idx="30">
                  <c:v>0.23900478680132542</c:v>
                </c:pt>
                <c:pt idx="31">
                  <c:v>0.19183548731125616</c:v>
                </c:pt>
                <c:pt idx="32">
                  <c:v>9.3521742990932369E-2</c:v>
                </c:pt>
                <c:pt idx="33">
                  <c:v>0.19946498839262686</c:v>
                </c:pt>
                <c:pt idx="34">
                  <c:v>0.21864622214726484</c:v>
                </c:pt>
                <c:pt idx="35">
                  <c:v>0.16965801255977303</c:v>
                </c:pt>
                <c:pt idx="36">
                  <c:v>0.26877207732296277</c:v>
                </c:pt>
                <c:pt idx="37">
                  <c:v>0.12032953532781668</c:v>
                </c:pt>
                <c:pt idx="38">
                  <c:v>0.19657126778309092</c:v>
                </c:pt>
                <c:pt idx="39">
                  <c:v>0.34156816653108196</c:v>
                </c:pt>
                <c:pt idx="40">
                  <c:v>0.15369459612293895</c:v>
                </c:pt>
                <c:pt idx="41">
                  <c:v>0.1235701378003532</c:v>
                </c:pt>
                <c:pt idx="42">
                  <c:v>0.23209292843111967</c:v>
                </c:pt>
                <c:pt idx="43">
                  <c:v>0.12538574078850773</c:v>
                </c:pt>
                <c:pt idx="44">
                  <c:v>9.4259228357705505E-2</c:v>
                </c:pt>
                <c:pt idx="45">
                  <c:v>6.303350264886208E-2</c:v>
                </c:pt>
                <c:pt idx="46">
                  <c:v>5.9465131748645803E-2</c:v>
                </c:pt>
                <c:pt idx="47">
                  <c:v>4.4831173237564241E-2</c:v>
                </c:pt>
                <c:pt idx="48">
                  <c:v>1.7077912260163895E-2</c:v>
                </c:pt>
                <c:pt idx="49">
                  <c:v>5.186870175995556E-2</c:v>
                </c:pt>
                <c:pt idx="50">
                  <c:v>3.9939958630131556E-2</c:v>
                </c:pt>
                <c:pt idx="51">
                  <c:v>7.9803853747098155E-2</c:v>
                </c:pt>
                <c:pt idx="52">
                  <c:v>5.5566049921625428E-2</c:v>
                </c:pt>
                <c:pt idx="53">
                  <c:v>6.0685455068552947E-2</c:v>
                </c:pt>
                <c:pt idx="54">
                  <c:v>2.7865702692513743E-2</c:v>
                </c:pt>
                <c:pt idx="55">
                  <c:v>2.8827785493903708E-2</c:v>
                </c:pt>
                <c:pt idx="56">
                  <c:v>3.3557237742812364E-2</c:v>
                </c:pt>
                <c:pt idx="57">
                  <c:v>2.7009161392091113E-2</c:v>
                </c:pt>
                <c:pt idx="58">
                  <c:v>3.1447302029802178E-2</c:v>
                </c:pt>
                <c:pt idx="59">
                  <c:v>3.2617695116022978E-2</c:v>
                </c:pt>
                <c:pt idx="60">
                  <c:v>5.2503666739419433E-2</c:v>
                </c:pt>
                <c:pt idx="61">
                  <c:v>5.7550315482450057E-2</c:v>
                </c:pt>
                <c:pt idx="62">
                  <c:v>6.197713506746131E-2</c:v>
                </c:pt>
                <c:pt idx="63">
                  <c:v>4.5079206432667315E-2</c:v>
                </c:pt>
                <c:pt idx="64">
                  <c:v>6.4081856286831093E-2</c:v>
                </c:pt>
                <c:pt idx="65">
                  <c:v>0.14721596906684656</c:v>
                </c:pt>
                <c:pt idx="66">
                  <c:v>0.12012743705232247</c:v>
                </c:pt>
                <c:pt idx="67">
                  <c:v>4.2023437468997407E-2</c:v>
                </c:pt>
                <c:pt idx="68">
                  <c:v>7.749549147800551E-2</c:v>
                </c:pt>
                <c:pt idx="69">
                  <c:v>9.5234825591777636E-2</c:v>
                </c:pt>
                <c:pt idx="70">
                  <c:v>8.2128751562531008E-2</c:v>
                </c:pt>
                <c:pt idx="71">
                  <c:v>0.16387057134070121</c:v>
                </c:pt>
                <c:pt idx="72">
                  <c:v>9.3392765729478758E-2</c:v>
                </c:pt>
                <c:pt idx="73">
                  <c:v>0.17629207375146336</c:v>
                </c:pt>
                <c:pt idx="74">
                  <c:v>0.11983852964811161</c:v>
                </c:pt>
                <c:pt idx="75">
                  <c:v>0.18402409522014329</c:v>
                </c:pt>
                <c:pt idx="76">
                  <c:v>0.179764538482906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966-499D-BCE2-53C41188D6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7726504"/>
        <c:axId val="197730032"/>
      </c:barChart>
      <c:catAx>
        <c:axId val="197726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lang="ja-JP" sz="7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730032"/>
        <c:crosses val="autoZero"/>
        <c:auto val="1"/>
        <c:lblAlgn val="ctr"/>
        <c:lblOffset val="100"/>
        <c:noMultiLvlLbl val="0"/>
      </c:catAx>
      <c:valAx>
        <c:axId val="197730032"/>
        <c:scaling>
          <c:orientation val="minMax"/>
          <c:max val="0.60000000000000009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97726504"/>
        <c:crosses val="autoZero"/>
        <c:crossBetween val="between"/>
        <c:majorUnit val="0.1500000000000000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FF62A6-826A-450F-84E7-84B593BB4253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GB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CFD1ED-E492-4D50-9672-14FDE353D25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04009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6B1AE9E-4C91-422A-B887-87B95C3F927A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85900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4619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108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72281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29689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2332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7083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3015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93213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5964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014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3420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E6DA07-65A6-4A94-B026-511C5C9865CA}" type="datetimeFigureOut">
              <a:rPr lang="en-GB" smtClean="0"/>
              <a:t>01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2310F-687D-459B-A716-ED74887A8CF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08084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-37496" y="3222872"/>
            <a:ext cx="5826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μ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109247" y="79431"/>
            <a:ext cx="280846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35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正方形/長方形 22"/>
          <p:cNvSpPr/>
          <p:nvPr/>
        </p:nvSpPr>
        <p:spPr>
          <a:xfrm>
            <a:off x="-33453" y="291437"/>
            <a:ext cx="582661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μ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/</a:t>
            </a:r>
            <a:r>
              <a:rPr lang="en-US" sz="10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</a:t>
            </a:r>
            <a:r>
              <a:rPr lang="en-US" sz="10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GB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GB" sz="10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7" name="正方形/長方形 46"/>
          <p:cNvSpPr/>
          <p:nvPr/>
        </p:nvSpPr>
        <p:spPr>
          <a:xfrm>
            <a:off x="124630" y="2994551"/>
            <a:ext cx="290464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350" b="1" dirty="0">
                <a:latin typeface="Arial" panose="020B0604020202020204" pitchFamily="34" charset="0"/>
                <a:ea typeface="HGPｺﾞｼｯｸE" panose="020B0900000000000000" pitchFamily="50" charset="-128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3" name="正方形/長方形 42"/>
          <p:cNvSpPr/>
          <p:nvPr/>
        </p:nvSpPr>
        <p:spPr>
          <a:xfrm>
            <a:off x="1966181" y="396729"/>
            <a:ext cx="559967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46" name="正方形/長方形 45"/>
          <p:cNvSpPr/>
          <p:nvPr/>
        </p:nvSpPr>
        <p:spPr>
          <a:xfrm>
            <a:off x="841039" y="394303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48" name="正方形/長方形 47"/>
          <p:cNvSpPr/>
          <p:nvPr/>
        </p:nvSpPr>
        <p:spPr>
          <a:xfrm>
            <a:off x="3140428" y="395482"/>
            <a:ext cx="63230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49" name="正方形/長方形 48"/>
          <p:cNvSpPr/>
          <p:nvPr/>
        </p:nvSpPr>
        <p:spPr>
          <a:xfrm>
            <a:off x="4368589" y="395478"/>
            <a:ext cx="62466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831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50" name="正方形/長方形 49"/>
          <p:cNvSpPr/>
          <p:nvPr/>
        </p:nvSpPr>
        <p:spPr>
          <a:xfrm>
            <a:off x="5507220" y="395479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51" name="正方形/長方形 50"/>
          <p:cNvSpPr/>
          <p:nvPr/>
        </p:nvSpPr>
        <p:spPr>
          <a:xfrm>
            <a:off x="6735674" y="395484"/>
            <a:ext cx="695382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52" name="正方形/長方形 51"/>
          <p:cNvSpPr/>
          <p:nvPr/>
        </p:nvSpPr>
        <p:spPr>
          <a:xfrm>
            <a:off x="7899741" y="397215"/>
            <a:ext cx="57634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sp>
        <p:nvSpPr>
          <p:cNvPr id="60" name="正方形/長方形 59"/>
          <p:cNvSpPr/>
          <p:nvPr/>
        </p:nvSpPr>
        <p:spPr>
          <a:xfrm>
            <a:off x="1951315" y="3314630"/>
            <a:ext cx="559967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1</a:t>
            </a:r>
          </a:p>
        </p:txBody>
      </p:sp>
      <p:sp>
        <p:nvSpPr>
          <p:cNvPr id="61" name="正方形/長方形 60"/>
          <p:cNvSpPr/>
          <p:nvPr/>
        </p:nvSpPr>
        <p:spPr>
          <a:xfrm>
            <a:off x="837324" y="3312204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1</a:t>
            </a:r>
          </a:p>
        </p:txBody>
      </p:sp>
      <p:sp>
        <p:nvSpPr>
          <p:cNvPr id="62" name="正方形/長方形 61"/>
          <p:cNvSpPr/>
          <p:nvPr/>
        </p:nvSpPr>
        <p:spPr>
          <a:xfrm>
            <a:off x="3125562" y="3313383"/>
            <a:ext cx="63230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1</a:t>
            </a:r>
          </a:p>
        </p:txBody>
      </p:sp>
      <p:sp>
        <p:nvSpPr>
          <p:cNvPr id="63" name="正方形/長方形 62"/>
          <p:cNvSpPr/>
          <p:nvPr/>
        </p:nvSpPr>
        <p:spPr>
          <a:xfrm>
            <a:off x="4364874" y="3313379"/>
            <a:ext cx="62466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mmer</a:t>
            </a:r>
            <a:endParaRPr lang="en-GB" sz="831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64" name="正方形/長方形 63"/>
          <p:cNvSpPr/>
          <p:nvPr/>
        </p:nvSpPr>
        <p:spPr>
          <a:xfrm>
            <a:off x="5503505" y="3313380"/>
            <a:ext cx="607639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tumn 2</a:t>
            </a:r>
          </a:p>
        </p:txBody>
      </p:sp>
      <p:sp>
        <p:nvSpPr>
          <p:cNvPr id="65" name="正方形/長方形 64"/>
          <p:cNvSpPr/>
          <p:nvPr/>
        </p:nvSpPr>
        <p:spPr>
          <a:xfrm>
            <a:off x="6731959" y="3313385"/>
            <a:ext cx="695382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nter 2</a:t>
            </a:r>
          </a:p>
        </p:txBody>
      </p:sp>
      <p:sp>
        <p:nvSpPr>
          <p:cNvPr id="66" name="正方形/長方形 65"/>
          <p:cNvSpPr/>
          <p:nvPr/>
        </p:nvSpPr>
        <p:spPr>
          <a:xfrm>
            <a:off x="7896026" y="3315116"/>
            <a:ext cx="576343" cy="220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83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ring 2</a:t>
            </a:r>
          </a:p>
        </p:txBody>
      </p:sp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32552870"/>
              </p:ext>
            </p:extLst>
          </p:nvPr>
        </p:nvGraphicFramePr>
        <p:xfrm>
          <a:off x="111512" y="451625"/>
          <a:ext cx="8820615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0" name="グラフ 3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61031291"/>
              </p:ext>
            </p:extLst>
          </p:nvPr>
        </p:nvGraphicFramePr>
        <p:xfrm>
          <a:off x="0" y="2979325"/>
          <a:ext cx="8884920" cy="31203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75" name="直線矢印コネクタ 74"/>
          <p:cNvCxnSpPr/>
          <p:nvPr/>
        </p:nvCxnSpPr>
        <p:spPr>
          <a:xfrm>
            <a:off x="1501486" y="3517323"/>
            <a:ext cx="1163782" cy="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線矢印コネクタ 75"/>
          <p:cNvCxnSpPr/>
          <p:nvPr/>
        </p:nvCxnSpPr>
        <p:spPr>
          <a:xfrm>
            <a:off x="2670464" y="3517323"/>
            <a:ext cx="1172890" cy="557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矢印コネクタ 76"/>
          <p:cNvCxnSpPr/>
          <p:nvPr/>
        </p:nvCxnSpPr>
        <p:spPr>
          <a:xfrm flipV="1">
            <a:off x="3848916" y="3522902"/>
            <a:ext cx="1280161" cy="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直線矢印コネクタ 77"/>
          <p:cNvCxnSpPr/>
          <p:nvPr/>
        </p:nvCxnSpPr>
        <p:spPr>
          <a:xfrm>
            <a:off x="5129077" y="3522896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矢印コネクタ 78"/>
          <p:cNvCxnSpPr/>
          <p:nvPr/>
        </p:nvCxnSpPr>
        <p:spPr>
          <a:xfrm>
            <a:off x="7468843" y="3526483"/>
            <a:ext cx="1210736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直線矢印コネクタ 79"/>
          <p:cNvCxnSpPr/>
          <p:nvPr/>
        </p:nvCxnSpPr>
        <p:spPr>
          <a:xfrm>
            <a:off x="6312419" y="3528097"/>
            <a:ext cx="1158900" cy="88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直線矢印コネクタ 80"/>
          <p:cNvCxnSpPr/>
          <p:nvPr/>
        </p:nvCxnSpPr>
        <p:spPr>
          <a:xfrm flipV="1">
            <a:off x="435200" y="3517323"/>
            <a:ext cx="1061091" cy="2520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/>
          <p:cNvCxnSpPr/>
          <p:nvPr/>
        </p:nvCxnSpPr>
        <p:spPr>
          <a:xfrm flipV="1">
            <a:off x="1589809" y="592282"/>
            <a:ext cx="1148196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矢印コネクタ 82"/>
          <p:cNvCxnSpPr/>
          <p:nvPr/>
        </p:nvCxnSpPr>
        <p:spPr>
          <a:xfrm>
            <a:off x="2746116" y="597234"/>
            <a:ext cx="1177537" cy="108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矢印コネクタ 83"/>
          <p:cNvCxnSpPr/>
          <p:nvPr/>
        </p:nvCxnSpPr>
        <p:spPr>
          <a:xfrm flipV="1">
            <a:off x="3934410" y="597564"/>
            <a:ext cx="1280161" cy="5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矢印コネクタ 84"/>
          <p:cNvCxnSpPr/>
          <p:nvPr/>
        </p:nvCxnSpPr>
        <p:spPr>
          <a:xfrm>
            <a:off x="5214571" y="597558"/>
            <a:ext cx="1182152" cy="3587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/>
          <p:cNvCxnSpPr/>
          <p:nvPr/>
        </p:nvCxnSpPr>
        <p:spPr>
          <a:xfrm>
            <a:off x="7554337" y="601145"/>
            <a:ext cx="1210736" cy="1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矢印コネクタ 86"/>
          <p:cNvCxnSpPr/>
          <p:nvPr/>
        </p:nvCxnSpPr>
        <p:spPr>
          <a:xfrm>
            <a:off x="6397913" y="597564"/>
            <a:ext cx="1158900" cy="88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矢印コネクタ 87"/>
          <p:cNvCxnSpPr/>
          <p:nvPr/>
        </p:nvCxnSpPr>
        <p:spPr>
          <a:xfrm>
            <a:off x="520694" y="594505"/>
            <a:ext cx="1057792" cy="3053"/>
          </a:xfrm>
          <a:prstGeom prst="straightConnector1">
            <a:avLst/>
          </a:prstGeom>
          <a:ln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F4221AD1-CD74-4F48-A7AE-58CA877EC1C7}"/>
              </a:ext>
            </a:extLst>
          </p:cNvPr>
          <p:cNvSpPr/>
          <p:nvPr/>
        </p:nvSpPr>
        <p:spPr>
          <a:xfrm>
            <a:off x="3783307" y="6408355"/>
            <a:ext cx="5252219" cy="338554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ohammad Shahriar Khan </a:t>
            </a:r>
            <a:r>
              <a:rPr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 al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,</a:t>
            </a:r>
            <a:r>
              <a:rPr lang="en-GB" altLang="ja-JP" sz="16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dditional file: Figure S2</a:t>
            </a:r>
            <a:endParaRPr lang="en-GB" sz="16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0267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1</TotalTime>
  <Words>52</Words>
  <Application>Microsoft Office PowerPoint</Application>
  <PresentationFormat>画面に合わせる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HGPｺﾞｼｯｸE</vt:lpstr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sei</dc:creator>
  <cp:lastModifiedBy>watanabe tetsushi</cp:lastModifiedBy>
  <cp:revision>24</cp:revision>
  <dcterms:created xsi:type="dcterms:W3CDTF">2018-05-24T05:21:23Z</dcterms:created>
  <dcterms:modified xsi:type="dcterms:W3CDTF">2018-08-01T03:19:28Z</dcterms:modified>
</cp:coreProperties>
</file>